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685800" y="1142640"/>
            <a:ext cx="548640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DDBC6A7-31FA-4208-90D7-5EA5FC22A206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82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3C5C799-7B67-4F15-BC1F-31F853633065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C7AAF3-5AC5-40A8-93E0-CC0602D319D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E165CA-0384-4F09-8DC0-DB0E3BEF1C9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8E851E-2832-476F-B88D-94033A5EDC0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7E2173-5E0E-4670-B1C9-E49A4BBFEC4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5BA081-4700-4371-A3C3-7D91C1FDD2C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F7E26C-4093-4A9C-8181-984AF2C5702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B161A9-D922-4495-A5A3-9469983377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42CB0B-28C3-4A77-97AC-D2CCD04A274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364275-54AD-4293-85D1-DE9651F5F0B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1AF92C-BB2D-4959-A3F9-396800F19F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08CA3D-2D80-4847-9F59-6D8E9A6B65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EF26A4-C152-4EA7-97FC-86F2812C92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4A2FEDE-D061-4398-B95F-7862EE49B142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5" descr=""/>
          <p:cNvPicPr/>
          <p:nvPr/>
        </p:nvPicPr>
        <p:blipFill>
          <a:blip r:embed="rId1"/>
          <a:srcRect l="874" t="0" r="0" b="0"/>
          <a:stretch/>
        </p:blipFill>
        <p:spPr>
          <a:xfrm>
            <a:off x="2185920" y="527040"/>
            <a:ext cx="9059760" cy="6226200"/>
          </a:xfrm>
          <a:prstGeom prst="rect">
            <a:avLst/>
          </a:prstGeom>
          <a:ln w="0">
            <a:noFill/>
          </a:ln>
        </p:spPr>
      </p:pic>
      <p:sp>
        <p:nvSpPr>
          <p:cNvPr id="49" name="TextBox 6"/>
          <p:cNvSpPr/>
          <p:nvPr/>
        </p:nvSpPr>
        <p:spPr>
          <a:xfrm>
            <a:off x="1839960" y="139680"/>
            <a:ext cx="9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Supplementary Figure S1:  Alignment of hemolysin protein sequences observed in this study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7"/>
          <p:cNvSpPr/>
          <p:nvPr/>
        </p:nvSpPr>
        <p:spPr>
          <a:xfrm>
            <a:off x="1503360" y="477720"/>
            <a:ext cx="130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ariant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8"/>
          <p:cNvSpPr/>
          <p:nvPr/>
        </p:nvSpPr>
        <p:spPr>
          <a:xfrm>
            <a:off x="1503360" y="650880"/>
            <a:ext cx="130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ariant 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9"/>
          <p:cNvSpPr/>
          <p:nvPr/>
        </p:nvSpPr>
        <p:spPr>
          <a:xfrm>
            <a:off x="1503360" y="814320"/>
            <a:ext cx="130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ariant 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0"/>
          <p:cNvSpPr/>
          <p:nvPr/>
        </p:nvSpPr>
        <p:spPr>
          <a:xfrm>
            <a:off x="1503360" y="1098720"/>
            <a:ext cx="130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ariant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11"/>
          <p:cNvSpPr/>
          <p:nvPr/>
        </p:nvSpPr>
        <p:spPr>
          <a:xfrm>
            <a:off x="1503360" y="1271520"/>
            <a:ext cx="130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ariant 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12"/>
          <p:cNvSpPr/>
          <p:nvPr/>
        </p:nvSpPr>
        <p:spPr>
          <a:xfrm>
            <a:off x="1503360" y="1434960"/>
            <a:ext cx="130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ariant 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13"/>
          <p:cNvSpPr/>
          <p:nvPr/>
        </p:nvSpPr>
        <p:spPr>
          <a:xfrm>
            <a:off x="1503360" y="1744560"/>
            <a:ext cx="130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ariant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14"/>
          <p:cNvSpPr/>
          <p:nvPr/>
        </p:nvSpPr>
        <p:spPr>
          <a:xfrm>
            <a:off x="1503360" y="1917720"/>
            <a:ext cx="130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ariant 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15"/>
          <p:cNvSpPr/>
          <p:nvPr/>
        </p:nvSpPr>
        <p:spPr>
          <a:xfrm>
            <a:off x="1503360" y="2081160"/>
            <a:ext cx="130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ariant 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16"/>
          <p:cNvSpPr/>
          <p:nvPr/>
        </p:nvSpPr>
        <p:spPr>
          <a:xfrm>
            <a:off x="1503360" y="2373480"/>
            <a:ext cx="130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ariant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17"/>
          <p:cNvSpPr/>
          <p:nvPr/>
        </p:nvSpPr>
        <p:spPr>
          <a:xfrm>
            <a:off x="1503360" y="2546280"/>
            <a:ext cx="130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ariant 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18"/>
          <p:cNvSpPr/>
          <p:nvPr/>
        </p:nvSpPr>
        <p:spPr>
          <a:xfrm>
            <a:off x="1503360" y="2709720"/>
            <a:ext cx="130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ariant 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19"/>
          <p:cNvSpPr/>
          <p:nvPr/>
        </p:nvSpPr>
        <p:spPr>
          <a:xfrm>
            <a:off x="1503360" y="3021120"/>
            <a:ext cx="130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ariant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20"/>
          <p:cNvSpPr/>
          <p:nvPr/>
        </p:nvSpPr>
        <p:spPr>
          <a:xfrm>
            <a:off x="1503360" y="3195720"/>
            <a:ext cx="130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ariant 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21"/>
          <p:cNvSpPr/>
          <p:nvPr/>
        </p:nvSpPr>
        <p:spPr>
          <a:xfrm>
            <a:off x="1503360" y="3357720"/>
            <a:ext cx="130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ariant 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22"/>
          <p:cNvSpPr/>
          <p:nvPr/>
        </p:nvSpPr>
        <p:spPr>
          <a:xfrm>
            <a:off x="1503360" y="3625920"/>
            <a:ext cx="130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ariant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23"/>
          <p:cNvSpPr/>
          <p:nvPr/>
        </p:nvSpPr>
        <p:spPr>
          <a:xfrm>
            <a:off x="1503360" y="3798720"/>
            <a:ext cx="130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ariant 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24"/>
          <p:cNvSpPr/>
          <p:nvPr/>
        </p:nvSpPr>
        <p:spPr>
          <a:xfrm>
            <a:off x="1503360" y="3962520"/>
            <a:ext cx="130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ariant 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25"/>
          <p:cNvSpPr/>
          <p:nvPr/>
        </p:nvSpPr>
        <p:spPr>
          <a:xfrm>
            <a:off x="1503360" y="4255920"/>
            <a:ext cx="130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ariant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26"/>
          <p:cNvSpPr/>
          <p:nvPr/>
        </p:nvSpPr>
        <p:spPr>
          <a:xfrm>
            <a:off x="1503360" y="4430880"/>
            <a:ext cx="130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ariant 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27"/>
          <p:cNvSpPr/>
          <p:nvPr/>
        </p:nvSpPr>
        <p:spPr>
          <a:xfrm>
            <a:off x="1503360" y="4592520"/>
            <a:ext cx="130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ariant 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28"/>
          <p:cNvSpPr/>
          <p:nvPr/>
        </p:nvSpPr>
        <p:spPr>
          <a:xfrm>
            <a:off x="1503360" y="4861080"/>
            <a:ext cx="130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ariant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29"/>
          <p:cNvSpPr/>
          <p:nvPr/>
        </p:nvSpPr>
        <p:spPr>
          <a:xfrm>
            <a:off x="1503360" y="5033880"/>
            <a:ext cx="130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ariant 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30"/>
          <p:cNvSpPr/>
          <p:nvPr/>
        </p:nvSpPr>
        <p:spPr>
          <a:xfrm>
            <a:off x="1503360" y="5197320"/>
            <a:ext cx="130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ariant 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31"/>
          <p:cNvSpPr/>
          <p:nvPr/>
        </p:nvSpPr>
        <p:spPr>
          <a:xfrm>
            <a:off x="1503360" y="5522760"/>
            <a:ext cx="130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ariant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32"/>
          <p:cNvSpPr/>
          <p:nvPr/>
        </p:nvSpPr>
        <p:spPr>
          <a:xfrm>
            <a:off x="1503360" y="5695920"/>
            <a:ext cx="130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ariant 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33"/>
          <p:cNvSpPr/>
          <p:nvPr/>
        </p:nvSpPr>
        <p:spPr>
          <a:xfrm>
            <a:off x="1503360" y="5859360"/>
            <a:ext cx="130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ariant 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34"/>
          <p:cNvSpPr/>
          <p:nvPr/>
        </p:nvSpPr>
        <p:spPr>
          <a:xfrm>
            <a:off x="1503360" y="6127920"/>
            <a:ext cx="130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ariant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35"/>
          <p:cNvSpPr/>
          <p:nvPr/>
        </p:nvSpPr>
        <p:spPr>
          <a:xfrm>
            <a:off x="1503360" y="6300720"/>
            <a:ext cx="130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ariant 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36"/>
          <p:cNvSpPr/>
          <p:nvPr/>
        </p:nvSpPr>
        <p:spPr>
          <a:xfrm>
            <a:off x="1503360" y="6464160"/>
            <a:ext cx="130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ariant 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1"/>
          <p:cNvSpPr/>
          <p:nvPr/>
        </p:nvSpPr>
        <p:spPr>
          <a:xfrm>
            <a:off x="5338800" y="6291360"/>
            <a:ext cx="60228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Legend:  Alignment of hemolysin protein variant sequences.  Variant numbers assigned to each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M. bovi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 strain are in Figure 1 and Supplementary File S1.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02-10T21:09:39Z</dcterms:created>
  <dc:creator>Clawson, Mike - ARS</dc:creator>
  <dc:description/>
  <dc:language>en-US</dc:language>
  <cp:lastModifiedBy>Clawson, Mike - ARS</cp:lastModifiedBy>
  <dcterms:modified xsi:type="dcterms:W3CDTF">2022-09-28T17:36:32Z</dcterms:modified>
  <cp:revision>17</cp:revision>
  <dc:subject/>
  <dc:title>PowerPoint Presentation</dc:title>
</cp:coreProperties>
</file>